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26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42E4AA91-EA64-446C-A194-611C4975D362}">
          <p14:sldIdLst>
            <p14:sldId id="264"/>
          </p14:sldIdLst>
        </p14:section>
        <p14:section name="ESA outcome" id="{41F9030B-E1EE-4027-AE01-2EC68ECF7A49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120" y="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C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F$2:$F$18,Sheet2!$F$19:$F$24)</c:f>
                <c:numCache>
                  <c:formatCode>General</c:formatCode>
                  <c:ptCount val="23"/>
                  <c:pt idx="0">
                    <c:v>0.36670000000000003</c:v>
                  </c:pt>
                  <c:pt idx="1">
                    <c:v>0.31240000000000001</c:v>
                  </c:pt>
                  <c:pt idx="2">
                    <c:v>0.34110000000000001</c:v>
                  </c:pt>
                  <c:pt idx="3">
                    <c:v>0.3962</c:v>
                  </c:pt>
                  <c:pt idx="4">
                    <c:v>0.2787</c:v>
                  </c:pt>
                  <c:pt idx="6">
                    <c:v>0.38490000000000002</c:v>
                  </c:pt>
                  <c:pt idx="7">
                    <c:v>0.31759999999999999</c:v>
                  </c:pt>
                  <c:pt idx="8">
                    <c:v>0.29980000000000001</c:v>
                  </c:pt>
                  <c:pt idx="9">
                    <c:v>0.31929999999999997</c:v>
                  </c:pt>
                  <c:pt idx="10">
                    <c:v>0.1978</c:v>
                  </c:pt>
                  <c:pt idx="12">
                    <c:v>0.2495</c:v>
                  </c:pt>
                  <c:pt idx="13">
                    <c:v>0.23469999999999999</c:v>
                  </c:pt>
                  <c:pt idx="14">
                    <c:v>0.22919999999999999</c:v>
                  </c:pt>
                  <c:pt idx="15">
                    <c:v>0.25259999999999999</c:v>
                  </c:pt>
                  <c:pt idx="16">
                    <c:v>0.17699999999999999</c:v>
                  </c:pt>
                  <c:pt idx="18">
                    <c:v>0.4405</c:v>
                  </c:pt>
                  <c:pt idx="19">
                    <c:v>0.48780000000000001</c:v>
                  </c:pt>
                  <c:pt idx="20">
                    <c:v>0.55869999999999997</c:v>
                  </c:pt>
                  <c:pt idx="21">
                    <c:v>0.49180000000000001</c:v>
                  </c:pt>
                  <c:pt idx="22">
                    <c:v>0.50600000000000001</c:v>
                  </c:pt>
                </c:numCache>
              </c:numRef>
            </c:plus>
            <c:minus>
              <c:numRef>
                <c:f>(Sheet2!$F$2:$F$18,Sheet2!$F$19:$F$24)</c:f>
                <c:numCache>
                  <c:formatCode>General</c:formatCode>
                  <c:ptCount val="23"/>
                  <c:pt idx="0">
                    <c:v>0.36670000000000003</c:v>
                  </c:pt>
                  <c:pt idx="1">
                    <c:v>0.31240000000000001</c:v>
                  </c:pt>
                  <c:pt idx="2">
                    <c:v>0.34110000000000001</c:v>
                  </c:pt>
                  <c:pt idx="3">
                    <c:v>0.3962</c:v>
                  </c:pt>
                  <c:pt idx="4">
                    <c:v>0.2787</c:v>
                  </c:pt>
                  <c:pt idx="6">
                    <c:v>0.38490000000000002</c:v>
                  </c:pt>
                  <c:pt idx="7">
                    <c:v>0.31759999999999999</c:v>
                  </c:pt>
                  <c:pt idx="8">
                    <c:v>0.29980000000000001</c:v>
                  </c:pt>
                  <c:pt idx="9">
                    <c:v>0.31929999999999997</c:v>
                  </c:pt>
                  <c:pt idx="10">
                    <c:v>0.1978</c:v>
                  </c:pt>
                  <c:pt idx="12">
                    <c:v>0.2495</c:v>
                  </c:pt>
                  <c:pt idx="13">
                    <c:v>0.23469999999999999</c:v>
                  </c:pt>
                  <c:pt idx="14">
                    <c:v>0.22919999999999999</c:v>
                  </c:pt>
                  <c:pt idx="15">
                    <c:v>0.25259999999999999</c:v>
                  </c:pt>
                  <c:pt idx="16">
                    <c:v>0.17699999999999999</c:v>
                  </c:pt>
                  <c:pt idx="18">
                    <c:v>0.4405</c:v>
                  </c:pt>
                  <c:pt idx="19">
                    <c:v>0.48780000000000001</c:v>
                  </c:pt>
                  <c:pt idx="20">
                    <c:v>0.55869999999999997</c:v>
                  </c:pt>
                  <c:pt idx="21">
                    <c:v>0.49180000000000001</c:v>
                  </c:pt>
                  <c:pt idx="22">
                    <c:v>0.50600000000000001</c:v>
                  </c:pt>
                </c:numCache>
              </c:numRef>
            </c:minus>
          </c:errBars>
          <c:xVal>
            <c:numRef>
              <c:f>Sheet2!$J$2:$J$24</c:f>
              <c:numCache>
                <c:formatCode>General</c:formatCode>
                <c:ptCount val="23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  <c:pt idx="5">
                  <c:v>5.3</c:v>
                </c:pt>
                <c:pt idx="6">
                  <c:v>6.3</c:v>
                </c:pt>
                <c:pt idx="7">
                  <c:v>7.3</c:v>
                </c:pt>
                <c:pt idx="8">
                  <c:v>8.3000000000000007</c:v>
                </c:pt>
                <c:pt idx="9">
                  <c:v>9.3000000000000007</c:v>
                </c:pt>
                <c:pt idx="10">
                  <c:v>10.3</c:v>
                </c:pt>
                <c:pt idx="11">
                  <c:v>11.3</c:v>
                </c:pt>
                <c:pt idx="12">
                  <c:v>12.3</c:v>
                </c:pt>
                <c:pt idx="13">
                  <c:v>13.3</c:v>
                </c:pt>
                <c:pt idx="14">
                  <c:v>14.3</c:v>
                </c:pt>
                <c:pt idx="15">
                  <c:v>15.3</c:v>
                </c:pt>
                <c:pt idx="16">
                  <c:v>16.3</c:v>
                </c:pt>
                <c:pt idx="17">
                  <c:v>17.3</c:v>
                </c:pt>
                <c:pt idx="18">
                  <c:v>18.3</c:v>
                </c:pt>
                <c:pt idx="19">
                  <c:v>19.3</c:v>
                </c:pt>
                <c:pt idx="20">
                  <c:v>20.3</c:v>
                </c:pt>
                <c:pt idx="21">
                  <c:v>21.3</c:v>
                </c:pt>
                <c:pt idx="22">
                  <c:v>22.3</c:v>
                </c:pt>
              </c:numCache>
            </c:numRef>
          </c:xVal>
          <c:yVal>
            <c:numRef>
              <c:f>Sheet2!$C$2:$C$24</c:f>
              <c:numCache>
                <c:formatCode>General</c:formatCode>
                <c:ptCount val="23"/>
                <c:pt idx="0">
                  <c:v>-0.25950000000000001</c:v>
                </c:pt>
                <c:pt idx="1">
                  <c:v>-0.67930000000000001</c:v>
                </c:pt>
                <c:pt idx="2">
                  <c:v>-0.64439999999999997</c:v>
                </c:pt>
                <c:pt idx="3">
                  <c:v>-0.41810000000000003</c:v>
                </c:pt>
                <c:pt idx="4">
                  <c:v>-0.87909999999999999</c:v>
                </c:pt>
                <c:pt idx="6">
                  <c:v>-0.28410000000000002</c:v>
                </c:pt>
                <c:pt idx="7">
                  <c:v>-0.48730000000000001</c:v>
                </c:pt>
                <c:pt idx="8">
                  <c:v>-0.27829999999999999</c:v>
                </c:pt>
                <c:pt idx="9">
                  <c:v>-0.18160000000000001</c:v>
                </c:pt>
                <c:pt idx="10">
                  <c:v>-0.2404</c:v>
                </c:pt>
                <c:pt idx="12">
                  <c:v>0.1454</c:v>
                </c:pt>
                <c:pt idx="13">
                  <c:v>-0.15920000000000001</c:v>
                </c:pt>
                <c:pt idx="14">
                  <c:v>-0.14219999999999999</c:v>
                </c:pt>
                <c:pt idx="15">
                  <c:v>-0.1489</c:v>
                </c:pt>
                <c:pt idx="16">
                  <c:v>-0.1401</c:v>
                </c:pt>
                <c:pt idx="18">
                  <c:v>-0.1052</c:v>
                </c:pt>
                <c:pt idx="19">
                  <c:v>-1.55E-2</c:v>
                </c:pt>
                <c:pt idx="20">
                  <c:v>-8.8700000000000001E-2</c:v>
                </c:pt>
                <c:pt idx="21">
                  <c:v>0.1298</c:v>
                </c:pt>
                <c:pt idx="22">
                  <c:v>-0.1683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78E-4AC2-957D-BD33A0AECDFB}"/>
            </c:ext>
          </c:extLst>
        </c:ser>
        <c:ser>
          <c:idx val="1"/>
          <c:order val="1"/>
          <c:tx>
            <c:strRef>
              <c:f>Sheet2!$D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G$2:$G$18,Sheet2!$G$19:$G$24)</c:f>
                <c:numCache>
                  <c:formatCode>General</c:formatCode>
                  <c:ptCount val="23"/>
                  <c:pt idx="0">
                    <c:v>0.35339999999999999</c:v>
                  </c:pt>
                  <c:pt idx="1">
                    <c:v>0.31059999999999999</c:v>
                  </c:pt>
                  <c:pt idx="2">
                    <c:v>0.34620000000000001</c:v>
                  </c:pt>
                  <c:pt idx="3">
                    <c:v>0.36620000000000003</c:v>
                  </c:pt>
                  <c:pt idx="4">
                    <c:v>0.31259999999999999</c:v>
                  </c:pt>
                  <c:pt idx="6">
                    <c:v>0.28220000000000001</c:v>
                  </c:pt>
                  <c:pt idx="7">
                    <c:v>0.29580000000000001</c:v>
                  </c:pt>
                  <c:pt idx="8">
                    <c:v>0.22650000000000001</c:v>
                  </c:pt>
                  <c:pt idx="9">
                    <c:v>0.26950000000000002</c:v>
                  </c:pt>
                  <c:pt idx="10">
                    <c:v>0.19309999999999999</c:v>
                  </c:pt>
                  <c:pt idx="12">
                    <c:v>0.17710000000000001</c:v>
                  </c:pt>
                  <c:pt idx="13">
                    <c:v>0.17949999999999999</c:v>
                  </c:pt>
                  <c:pt idx="14">
                    <c:v>0.18129999999999999</c:v>
                  </c:pt>
                  <c:pt idx="15">
                    <c:v>0.2087</c:v>
                  </c:pt>
                  <c:pt idx="16">
                    <c:v>0.16569999999999999</c:v>
                  </c:pt>
                  <c:pt idx="18">
                    <c:v>0.33539999999999998</c:v>
                  </c:pt>
                  <c:pt idx="19">
                    <c:v>0.41720000000000002</c:v>
                  </c:pt>
                  <c:pt idx="20">
                    <c:v>0.40660000000000002</c:v>
                  </c:pt>
                  <c:pt idx="21">
                    <c:v>0.52580000000000005</c:v>
                  </c:pt>
                  <c:pt idx="22">
                    <c:v>0.44879999999999998</c:v>
                  </c:pt>
                </c:numCache>
              </c:numRef>
            </c:plus>
            <c:minus>
              <c:numRef>
                <c:f>(Sheet2!$G$2:$G$18,Sheet2!$G$19:$G$24)</c:f>
                <c:numCache>
                  <c:formatCode>General</c:formatCode>
                  <c:ptCount val="23"/>
                  <c:pt idx="0">
                    <c:v>0.35339999999999999</c:v>
                  </c:pt>
                  <c:pt idx="1">
                    <c:v>0.31059999999999999</c:v>
                  </c:pt>
                  <c:pt idx="2">
                    <c:v>0.34620000000000001</c:v>
                  </c:pt>
                  <c:pt idx="3">
                    <c:v>0.36620000000000003</c:v>
                  </c:pt>
                  <c:pt idx="4">
                    <c:v>0.31259999999999999</c:v>
                  </c:pt>
                  <c:pt idx="6">
                    <c:v>0.28220000000000001</c:v>
                  </c:pt>
                  <c:pt idx="7">
                    <c:v>0.29580000000000001</c:v>
                  </c:pt>
                  <c:pt idx="8">
                    <c:v>0.22650000000000001</c:v>
                  </c:pt>
                  <c:pt idx="9">
                    <c:v>0.26950000000000002</c:v>
                  </c:pt>
                  <c:pt idx="10">
                    <c:v>0.19309999999999999</c:v>
                  </c:pt>
                  <c:pt idx="12">
                    <c:v>0.17710000000000001</c:v>
                  </c:pt>
                  <c:pt idx="13">
                    <c:v>0.17949999999999999</c:v>
                  </c:pt>
                  <c:pt idx="14">
                    <c:v>0.18129999999999999</c:v>
                  </c:pt>
                  <c:pt idx="15">
                    <c:v>0.2087</c:v>
                  </c:pt>
                  <c:pt idx="16">
                    <c:v>0.16569999999999999</c:v>
                  </c:pt>
                  <c:pt idx="18">
                    <c:v>0.33539999999999998</c:v>
                  </c:pt>
                  <c:pt idx="19">
                    <c:v>0.41720000000000002</c:v>
                  </c:pt>
                  <c:pt idx="20">
                    <c:v>0.40660000000000002</c:v>
                  </c:pt>
                  <c:pt idx="21">
                    <c:v>0.52580000000000005</c:v>
                  </c:pt>
                  <c:pt idx="22">
                    <c:v>0.44879999999999998</c:v>
                  </c:pt>
                </c:numCache>
              </c:numRef>
            </c:minus>
          </c:errBars>
          <c:xVal>
            <c:numRef>
              <c:f>Sheet2!$K$2:$K$24</c:f>
              <c:numCache>
                <c:formatCode>General</c:formatCode>
                <c:ptCount val="23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  <c:pt idx="5">
                  <c:v>5.5</c:v>
                </c:pt>
                <c:pt idx="6">
                  <c:v>6.5</c:v>
                </c:pt>
                <c:pt idx="7">
                  <c:v>7.5</c:v>
                </c:pt>
                <c:pt idx="8">
                  <c:v>8.5</c:v>
                </c:pt>
                <c:pt idx="9">
                  <c:v>9.5</c:v>
                </c:pt>
                <c:pt idx="10">
                  <c:v>10.5</c:v>
                </c:pt>
                <c:pt idx="11">
                  <c:v>11.5</c:v>
                </c:pt>
                <c:pt idx="12">
                  <c:v>12.5</c:v>
                </c:pt>
                <c:pt idx="13">
                  <c:v>13.5</c:v>
                </c:pt>
                <c:pt idx="14">
                  <c:v>14.5</c:v>
                </c:pt>
                <c:pt idx="15">
                  <c:v>15.5</c:v>
                </c:pt>
                <c:pt idx="16">
                  <c:v>16.5</c:v>
                </c:pt>
                <c:pt idx="17">
                  <c:v>17.5</c:v>
                </c:pt>
                <c:pt idx="18">
                  <c:v>18.5</c:v>
                </c:pt>
                <c:pt idx="19">
                  <c:v>19.5</c:v>
                </c:pt>
                <c:pt idx="20">
                  <c:v>20.5</c:v>
                </c:pt>
                <c:pt idx="21">
                  <c:v>21.5</c:v>
                </c:pt>
                <c:pt idx="22">
                  <c:v>22.5</c:v>
                </c:pt>
              </c:numCache>
            </c:numRef>
          </c:xVal>
          <c:yVal>
            <c:numRef>
              <c:f>(Sheet2!$D$2:$D$18,Sheet2!$D$19:$D$24)</c:f>
              <c:numCache>
                <c:formatCode>General</c:formatCode>
                <c:ptCount val="23"/>
                <c:pt idx="0">
                  <c:v>-0.20780000000000001</c:v>
                </c:pt>
                <c:pt idx="1">
                  <c:v>-0.62390000000000001</c:v>
                </c:pt>
                <c:pt idx="2">
                  <c:v>-0.50190000000000001</c:v>
                </c:pt>
                <c:pt idx="3">
                  <c:v>-0.5998</c:v>
                </c:pt>
                <c:pt idx="4">
                  <c:v>-0.5958</c:v>
                </c:pt>
                <c:pt idx="6">
                  <c:v>0.20619999999999999</c:v>
                </c:pt>
                <c:pt idx="7">
                  <c:v>-0.30809999999999998</c:v>
                </c:pt>
                <c:pt idx="8">
                  <c:v>-0.30830000000000002</c:v>
                </c:pt>
                <c:pt idx="9">
                  <c:v>-0.18559999999999999</c:v>
                </c:pt>
                <c:pt idx="10">
                  <c:v>-0.18770000000000001</c:v>
                </c:pt>
                <c:pt idx="12">
                  <c:v>9.5399999999999999E-2</c:v>
                </c:pt>
                <c:pt idx="13">
                  <c:v>4.8000000000000001E-2</c:v>
                </c:pt>
                <c:pt idx="14">
                  <c:v>-1.54E-2</c:v>
                </c:pt>
                <c:pt idx="15">
                  <c:v>0.13969999999999999</c:v>
                </c:pt>
                <c:pt idx="16">
                  <c:v>-6.4999999999999997E-3</c:v>
                </c:pt>
                <c:pt idx="18">
                  <c:v>0.81210000000000004</c:v>
                </c:pt>
                <c:pt idx="19">
                  <c:v>6.6400000000000001E-2</c:v>
                </c:pt>
                <c:pt idx="20">
                  <c:v>0.40710000000000002</c:v>
                </c:pt>
                <c:pt idx="21">
                  <c:v>0.29870000000000002</c:v>
                </c:pt>
                <c:pt idx="22">
                  <c:v>4.32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78E-4AC2-957D-BD33A0AECDFB}"/>
            </c:ext>
          </c:extLst>
        </c:ser>
        <c:ser>
          <c:idx val="2"/>
          <c:order val="2"/>
          <c:tx>
            <c:strRef>
              <c:f>Sheet2!$E$1</c:f>
              <c:strCache>
                <c:ptCount val="1"/>
                <c:pt idx="0">
                  <c:v> ≥300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2!$H$2:$H$18,Sheet2!$H$19:$H$24)</c:f>
                <c:numCache>
                  <c:formatCode>General</c:formatCode>
                  <c:ptCount val="23"/>
                  <c:pt idx="0">
                    <c:v>0.36990000000000001</c:v>
                  </c:pt>
                  <c:pt idx="1">
                    <c:v>0.39050000000000001</c:v>
                  </c:pt>
                  <c:pt idx="2">
                    <c:v>0.48039999999999999</c:v>
                  </c:pt>
                  <c:pt idx="3">
                    <c:v>0.5333</c:v>
                  </c:pt>
                  <c:pt idx="4">
                    <c:v>0.42330000000000001</c:v>
                  </c:pt>
                  <c:pt idx="6">
                    <c:v>0.30780000000000002</c:v>
                  </c:pt>
                  <c:pt idx="7">
                    <c:v>0.39040000000000002</c:v>
                  </c:pt>
                  <c:pt idx="8">
                    <c:v>0.4083</c:v>
                  </c:pt>
                  <c:pt idx="9">
                    <c:v>0.42459999999999998</c:v>
                  </c:pt>
                  <c:pt idx="10">
                    <c:v>0.34710000000000002</c:v>
                  </c:pt>
                  <c:pt idx="12">
                    <c:v>0.15529999999999999</c:v>
                  </c:pt>
                  <c:pt idx="13">
                    <c:v>0.19189999999999999</c:v>
                  </c:pt>
                  <c:pt idx="14">
                    <c:v>0.21490000000000001</c:v>
                  </c:pt>
                  <c:pt idx="15">
                    <c:v>0.27160000000000001</c:v>
                  </c:pt>
                  <c:pt idx="16">
                    <c:v>0.26889999999999997</c:v>
                  </c:pt>
                  <c:pt idx="18">
                    <c:v>0.252</c:v>
                  </c:pt>
                  <c:pt idx="19">
                    <c:v>0.3695</c:v>
                  </c:pt>
                  <c:pt idx="20">
                    <c:v>0.4395</c:v>
                  </c:pt>
                  <c:pt idx="21">
                    <c:v>0.54400000000000004</c:v>
                  </c:pt>
                  <c:pt idx="22">
                    <c:v>0.55089999999999995</c:v>
                  </c:pt>
                </c:numCache>
              </c:numRef>
            </c:plus>
            <c:minus>
              <c:numRef>
                <c:f>(Sheet2!$H$2:$H$18,Sheet2!$H$19:$H$24)</c:f>
                <c:numCache>
                  <c:formatCode>General</c:formatCode>
                  <c:ptCount val="23"/>
                  <c:pt idx="0">
                    <c:v>0.36990000000000001</c:v>
                  </c:pt>
                  <c:pt idx="1">
                    <c:v>0.39050000000000001</c:v>
                  </c:pt>
                  <c:pt idx="2">
                    <c:v>0.48039999999999999</c:v>
                  </c:pt>
                  <c:pt idx="3">
                    <c:v>0.5333</c:v>
                  </c:pt>
                  <c:pt idx="4">
                    <c:v>0.42330000000000001</c:v>
                  </c:pt>
                  <c:pt idx="6">
                    <c:v>0.30780000000000002</c:v>
                  </c:pt>
                  <c:pt idx="7">
                    <c:v>0.39040000000000002</c:v>
                  </c:pt>
                  <c:pt idx="8">
                    <c:v>0.4083</c:v>
                  </c:pt>
                  <c:pt idx="9">
                    <c:v>0.42459999999999998</c:v>
                  </c:pt>
                  <c:pt idx="10">
                    <c:v>0.34710000000000002</c:v>
                  </c:pt>
                  <c:pt idx="12">
                    <c:v>0.15529999999999999</c:v>
                  </c:pt>
                  <c:pt idx="13">
                    <c:v>0.19189999999999999</c:v>
                  </c:pt>
                  <c:pt idx="14">
                    <c:v>0.21490000000000001</c:v>
                  </c:pt>
                  <c:pt idx="15">
                    <c:v>0.27160000000000001</c:v>
                  </c:pt>
                  <c:pt idx="16">
                    <c:v>0.26889999999999997</c:v>
                  </c:pt>
                  <c:pt idx="18">
                    <c:v>0.252</c:v>
                  </c:pt>
                  <c:pt idx="19">
                    <c:v>0.3695</c:v>
                  </c:pt>
                  <c:pt idx="20">
                    <c:v>0.4395</c:v>
                  </c:pt>
                  <c:pt idx="21">
                    <c:v>0.54400000000000004</c:v>
                  </c:pt>
                  <c:pt idx="22">
                    <c:v>0.55089999999999995</c:v>
                  </c:pt>
                </c:numCache>
              </c:numRef>
            </c:minus>
          </c:errBars>
          <c:xVal>
            <c:numRef>
              <c:f>(Sheet2!$L$2:$L$18,Sheet2!$L$19:$L$24)</c:f>
              <c:numCache>
                <c:formatCode>General</c:formatCode>
                <c:ptCount val="23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  <c:pt idx="5">
                  <c:v>5.7</c:v>
                </c:pt>
                <c:pt idx="6">
                  <c:v>6.7</c:v>
                </c:pt>
                <c:pt idx="7">
                  <c:v>7.7</c:v>
                </c:pt>
                <c:pt idx="8">
                  <c:v>8.6999999999999993</c:v>
                </c:pt>
                <c:pt idx="9">
                  <c:v>9.6999999999999993</c:v>
                </c:pt>
                <c:pt idx="10">
                  <c:v>10.7</c:v>
                </c:pt>
                <c:pt idx="11">
                  <c:v>11.7</c:v>
                </c:pt>
                <c:pt idx="12">
                  <c:v>12.7</c:v>
                </c:pt>
                <c:pt idx="13">
                  <c:v>13.7</c:v>
                </c:pt>
                <c:pt idx="14">
                  <c:v>14.7</c:v>
                </c:pt>
                <c:pt idx="15">
                  <c:v>15.7</c:v>
                </c:pt>
                <c:pt idx="16">
                  <c:v>16.7</c:v>
                </c:pt>
                <c:pt idx="17">
                  <c:v>17.7</c:v>
                </c:pt>
                <c:pt idx="18">
                  <c:v>18.7</c:v>
                </c:pt>
                <c:pt idx="19">
                  <c:v>19.7</c:v>
                </c:pt>
                <c:pt idx="20">
                  <c:v>20.7</c:v>
                </c:pt>
                <c:pt idx="21">
                  <c:v>21.7</c:v>
                </c:pt>
                <c:pt idx="22">
                  <c:v>22.7</c:v>
                </c:pt>
              </c:numCache>
            </c:numRef>
          </c:xVal>
          <c:yVal>
            <c:numRef>
              <c:f>(Sheet2!$E$2:$E$18,Sheet2!$E$19:$E$24)</c:f>
              <c:numCache>
                <c:formatCode>General</c:formatCode>
                <c:ptCount val="23"/>
                <c:pt idx="0">
                  <c:v>-0.21640000000000001</c:v>
                </c:pt>
                <c:pt idx="1">
                  <c:v>-0.6845</c:v>
                </c:pt>
                <c:pt idx="2">
                  <c:v>-0.44690000000000002</c:v>
                </c:pt>
                <c:pt idx="3">
                  <c:v>-0.3836</c:v>
                </c:pt>
                <c:pt idx="4">
                  <c:v>-0.56000000000000005</c:v>
                </c:pt>
                <c:pt idx="6">
                  <c:v>0.21690000000000001</c:v>
                </c:pt>
                <c:pt idx="7">
                  <c:v>4.4400000000000002E-2</c:v>
                </c:pt>
                <c:pt idx="8">
                  <c:v>-3.0700000000000002E-2</c:v>
                </c:pt>
                <c:pt idx="9">
                  <c:v>0.4728</c:v>
                </c:pt>
                <c:pt idx="10">
                  <c:v>-0.27250000000000002</c:v>
                </c:pt>
                <c:pt idx="12">
                  <c:v>0.55769999999999997</c:v>
                </c:pt>
                <c:pt idx="13">
                  <c:v>0.223</c:v>
                </c:pt>
                <c:pt idx="14">
                  <c:v>0.24340000000000001</c:v>
                </c:pt>
                <c:pt idx="15">
                  <c:v>0.17560000000000001</c:v>
                </c:pt>
                <c:pt idx="16">
                  <c:v>0.1125</c:v>
                </c:pt>
                <c:pt idx="18">
                  <c:v>0.88560000000000005</c:v>
                </c:pt>
                <c:pt idx="19">
                  <c:v>0.71719999999999995</c:v>
                </c:pt>
                <c:pt idx="20">
                  <c:v>0.24160000000000001</c:v>
                </c:pt>
                <c:pt idx="21">
                  <c:v>0.20150000000000001</c:v>
                </c:pt>
                <c:pt idx="22">
                  <c:v>0.32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78E-4AC2-957D-BD33A0AECD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3069952"/>
        <c:axId val="163072256"/>
      </c:scatterChart>
      <c:valAx>
        <c:axId val="163069952"/>
        <c:scaling>
          <c:orientation val="minMax"/>
          <c:max val="23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163072256"/>
        <c:crosses val="autoZero"/>
        <c:crossBetween val="midCat"/>
        <c:majorUnit val="1"/>
      </c:valAx>
      <c:valAx>
        <c:axId val="163072256"/>
        <c:scaling>
          <c:orientation val="minMax"/>
          <c:max val="1.5"/>
          <c:min val="-1.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163069952"/>
        <c:crossesAt val="0"/>
        <c:crossBetween val="midCat"/>
        <c:majorUnit val="0.5"/>
      </c:valAx>
    </c:plotArea>
    <c:legend>
      <c:legendPos val="t"/>
      <c:layout>
        <c:manualLayout>
          <c:xMode val="edge"/>
          <c:yMode val="edge"/>
          <c:x val="0.61338063782822128"/>
          <c:y val="1.488095238095238E-2"/>
          <c:w val="0.38067950449708432"/>
          <c:h val="0.10417275965504312"/>
        </c:manualLayout>
      </c:layout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889AEC-34BF-4302-98B2-D9282C633FEA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E1375B-8075-47C2-BCCF-B6BE14E74E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454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5: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justed change in </a:t>
            </a:r>
            <a:r>
              <a:rPr lang="en-US" sz="1200" b="1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moglobi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rom before to after IV iron dosing</a:t>
            </a:r>
          </a:p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ratified by ESA and TSAT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72D4C8-8573-4530-8B8E-ACFA713CD155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2297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280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91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8697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3200" y="2743201"/>
            <a:ext cx="11684000" cy="1470025"/>
          </a:xfrm>
        </p:spPr>
        <p:txBody>
          <a:bodyPr/>
          <a:lstStyle>
            <a:lvl1pPr>
              <a:defRPr b="1">
                <a:solidFill>
                  <a:schemeClr val="tx2"/>
                </a:solidFill>
                <a:latin typeface="+mj-lt"/>
              </a:defRPr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4365625"/>
            <a:ext cx="8534400" cy="1752600"/>
          </a:xfrm>
        </p:spPr>
        <p:txBody>
          <a:bodyPr>
            <a:normAutofit/>
          </a:bodyPr>
          <a:lstStyle>
            <a:lvl1pPr marL="0" indent="0" algn="ctr">
              <a:buNone/>
              <a:defRPr sz="2800" b="1">
                <a:solidFill>
                  <a:schemeClr val="tx1"/>
                </a:solidFill>
                <a:latin typeface="+mj-lt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pic>
        <p:nvPicPr>
          <p:cNvPr id="7" name="Picture 5"/>
          <p:cNvPicPr>
            <a:picLocks noChangeAspect="1" noChangeArrowheads="1"/>
          </p:cNvPicPr>
          <p:nvPr userDrawn="1"/>
        </p:nvPicPr>
        <p:blipFill>
          <a:blip r:embed="rId2" cstate="print"/>
          <a:srcRect t="12068" r="7500" b="12508"/>
          <a:stretch>
            <a:fillRect/>
          </a:stretch>
        </p:blipFill>
        <p:spPr bwMode="auto">
          <a:xfrm>
            <a:off x="2336800" y="304800"/>
            <a:ext cx="7518400" cy="1905000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</p:pic>
      <p:sp>
        <p:nvSpPr>
          <p:cNvPr id="8" name="Text Box 6"/>
          <p:cNvSpPr txBox="1">
            <a:spLocks noChangeArrowheads="1"/>
          </p:cNvSpPr>
          <p:nvPr userDrawn="1"/>
        </p:nvSpPr>
        <p:spPr bwMode="auto">
          <a:xfrm>
            <a:off x="355600" y="2011363"/>
            <a:ext cx="11531600" cy="519112"/>
          </a:xfrm>
          <a:prstGeom prst="rect">
            <a:avLst/>
          </a:prstGeom>
          <a:noFill/>
          <a:ln w="12700">
            <a:noFill/>
            <a:miter lim="800000"/>
            <a:headEnd type="none" w="sm" len="sm"/>
            <a:tailEnd type="none" w="sm" len="sm"/>
          </a:ln>
          <a:effectLst/>
        </p:spPr>
        <p:txBody>
          <a:bodyPr>
            <a:spAutoFit/>
          </a:bodyPr>
          <a:lstStyle/>
          <a:p>
            <a:pPr algn="ctr" eaLnBrk="0" hangingPunct="0">
              <a:spcBef>
                <a:spcPct val="50000"/>
              </a:spcBef>
            </a:pPr>
            <a:r>
              <a:rPr lang="en-US" sz="2800" b="1" dirty="0">
                <a:solidFill>
                  <a:schemeClr val="tx1"/>
                </a:solidFill>
                <a:latin typeface="+mj-lt"/>
              </a:rPr>
              <a:t>Dialysis Outcomes and Practice Patterns Study</a:t>
            </a:r>
          </a:p>
        </p:txBody>
      </p:sp>
    </p:spTree>
    <p:extLst>
      <p:ext uri="{BB962C8B-B14F-4D97-AF65-F5344CB8AC3E}">
        <p14:creationId xmlns:p14="http://schemas.microsoft.com/office/powerpoint/2010/main" val="303217782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76200"/>
            <a:ext cx="10972800" cy="990600"/>
          </a:xfrm>
        </p:spPr>
        <p:txBody>
          <a:bodyPr>
            <a:normAutofit/>
          </a:bodyPr>
          <a:lstStyle>
            <a:lvl1pPr>
              <a:defRPr sz="3600" b="1">
                <a:solidFill>
                  <a:schemeClr val="tx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09600" y="1295400"/>
            <a:ext cx="10972800" cy="5029200"/>
          </a:xfrm>
        </p:spPr>
        <p:txBody>
          <a:bodyPr/>
          <a:lstStyle>
            <a:lvl1pPr>
              <a:defRPr sz="2600" b="1">
                <a:solidFill>
                  <a:schemeClr val="tx1"/>
                </a:solidFill>
                <a:latin typeface="+mj-lt"/>
              </a:defRPr>
            </a:lvl1pPr>
            <a:lvl2pPr>
              <a:defRPr sz="2300" b="1">
                <a:solidFill>
                  <a:schemeClr val="tx1"/>
                </a:solidFill>
                <a:latin typeface="+mj-lt"/>
              </a:defRPr>
            </a:lvl2pPr>
            <a:lvl3pPr>
              <a:defRPr sz="2000" b="1">
                <a:solidFill>
                  <a:schemeClr val="tx1"/>
                </a:solidFill>
                <a:latin typeface="+mj-lt"/>
              </a:defRPr>
            </a:lvl3pPr>
            <a:lvl4pPr>
              <a:defRPr sz="1800" b="1">
                <a:solidFill>
                  <a:schemeClr val="tx1"/>
                </a:solidFill>
                <a:latin typeface="+mj-lt"/>
              </a:defRPr>
            </a:lvl4pPr>
            <a:lvl5pPr>
              <a:buFont typeface="Arial" pitchFamily="34" charset="0"/>
              <a:buChar char="•"/>
              <a:defRPr sz="1800" b="1">
                <a:solidFill>
                  <a:schemeClr val="tx1"/>
                </a:solidFill>
                <a:latin typeface="+mj-lt"/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235725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10505800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>
                <a:solidFill>
                  <a:schemeClr val="tx1"/>
                </a:solidFill>
              </a:defRPr>
            </a:lvl1pPr>
            <a:lvl2pPr>
              <a:defRPr sz="2400">
                <a:solidFill>
                  <a:schemeClr val="tx1"/>
                </a:solidFill>
              </a:defRPr>
            </a:lvl2pPr>
            <a:lvl3pPr>
              <a:defRPr sz="2000">
                <a:solidFill>
                  <a:schemeClr val="tx1"/>
                </a:solidFill>
              </a:defRPr>
            </a:lvl3pPr>
            <a:lvl4pPr>
              <a:defRPr sz="18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800">
                <a:solidFill>
                  <a:schemeClr val="tx1"/>
                </a:solidFill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937084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>
                <a:solidFill>
                  <a:schemeClr val="tx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>
                <a:solidFill>
                  <a:schemeClr val="tx1"/>
                </a:solidFill>
              </a:defRPr>
            </a:lvl1pPr>
            <a:lvl2pPr>
              <a:defRPr sz="2000">
                <a:solidFill>
                  <a:schemeClr val="tx1"/>
                </a:solidFill>
              </a:defRPr>
            </a:lvl2pPr>
            <a:lvl3pPr>
              <a:defRPr sz="1800">
                <a:solidFill>
                  <a:schemeClr val="tx1"/>
                </a:solidFill>
              </a:defRPr>
            </a:lvl3pPr>
            <a:lvl4pPr>
              <a:defRPr sz="1600">
                <a:solidFill>
                  <a:schemeClr val="tx1"/>
                </a:solidFill>
              </a:defRPr>
            </a:lvl4pPr>
            <a:lvl5pPr>
              <a:buFont typeface="Arial" pitchFamily="34" charset="0"/>
              <a:buChar char="•"/>
              <a:defRPr sz="1600">
                <a:solidFill>
                  <a:schemeClr val="tx1"/>
                </a:solidFill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312826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88297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16064681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buFont typeface="Arial" pitchFamily="34" charset="0"/>
              <a:buChar char="•"/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263225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83518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609600" y="1600200"/>
            <a:ext cx="10972800" cy="4725988"/>
          </a:xfrm>
        </p:spPr>
        <p:txBody>
          <a:bodyPr/>
          <a:lstStyle/>
          <a:p>
            <a:pPr lvl="0"/>
            <a:r>
              <a:rPr lang="en-US" noProof="0" smtClean="0"/>
              <a:t>Click icon to add table</a:t>
            </a:r>
          </a:p>
        </p:txBody>
      </p:sp>
    </p:spTree>
    <p:extLst>
      <p:ext uri="{BB962C8B-B14F-4D97-AF65-F5344CB8AC3E}">
        <p14:creationId xmlns:p14="http://schemas.microsoft.com/office/powerpoint/2010/main" val="36350212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30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514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6906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501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071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769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877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A3B81D-D46C-4D4D-B007-CE646BCF1E60}" type="datetimeFigureOut">
              <a:rPr lang="en-US" smtClean="0"/>
              <a:t>5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6A1EE-2409-4B5C-BAFA-2EDBA490BD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35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76200"/>
            <a:ext cx="10972800" cy="9875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295400"/>
            <a:ext cx="10972800" cy="50292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5403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</p:sldLayoutIdLst>
  <p:txStyles>
    <p:titleStyle>
      <a:lvl1pPr algn="ctr" defTabSz="914400" rtl="0" eaLnBrk="1" latinLnBrk="0" hangingPunct="1">
        <a:spcBef>
          <a:spcPct val="0"/>
        </a:spcBef>
        <a:buNone/>
        <a:defRPr sz="36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2600" b="1" kern="1200">
          <a:solidFill>
            <a:schemeClr val="tx1"/>
          </a:solidFill>
          <a:latin typeface="+mj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300" b="1" kern="1200">
          <a:solidFill>
            <a:schemeClr val="tx1"/>
          </a:solidFill>
          <a:latin typeface="+mj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b="1" kern="1200">
          <a:solidFill>
            <a:schemeClr val="tx1"/>
          </a:solidFill>
          <a:latin typeface="+mj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800" b="1" kern="1200">
          <a:solidFill>
            <a:schemeClr val="tx1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40469852"/>
              </p:ext>
            </p:extLst>
          </p:nvPr>
        </p:nvGraphicFramePr>
        <p:xfrm>
          <a:off x="50799" y="1142999"/>
          <a:ext cx="12141201" cy="38621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867872"/>
            <a:ext cx="21451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prstClr val="black"/>
                </a:solidFill>
              </a:rPr>
              <a:t>Change in </a:t>
            </a:r>
            <a:r>
              <a:rPr lang="en-US" sz="1600" dirty="0" err="1">
                <a:solidFill>
                  <a:prstClr val="black"/>
                </a:solidFill>
              </a:rPr>
              <a:t>Hgb</a:t>
            </a:r>
            <a:r>
              <a:rPr lang="en-US" sz="1600" dirty="0">
                <a:solidFill>
                  <a:prstClr val="black"/>
                </a:solidFill>
              </a:rPr>
              <a:t> (g/</a:t>
            </a:r>
            <a:r>
              <a:rPr lang="en-US" sz="1600" dirty="0" err="1">
                <a:solidFill>
                  <a:prstClr val="black"/>
                </a:solidFill>
              </a:rPr>
              <a:t>dL</a:t>
            </a:r>
            <a:r>
              <a:rPr lang="en-US" sz="1600" dirty="0">
                <a:solidFill>
                  <a:prstClr val="black"/>
                </a:solidFill>
              </a:rPr>
              <a:t>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-135467" y="5233858"/>
            <a:ext cx="9482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solidFill>
                  <a:prstClr val="black"/>
                </a:solidFill>
              </a:rPr>
              <a:t>Strata:</a:t>
            </a:r>
          </a:p>
          <a:p>
            <a:pPr algn="r"/>
            <a:r>
              <a:rPr lang="en-US" sz="1600" dirty="0" smtClean="0">
                <a:solidFill>
                  <a:prstClr val="black"/>
                </a:solidFill>
              </a:rPr>
              <a:t>TSAT:</a:t>
            </a:r>
          </a:p>
          <a:p>
            <a:pPr algn="r"/>
            <a:r>
              <a:rPr lang="en-US" sz="1600" dirty="0" smtClean="0">
                <a:solidFill>
                  <a:prstClr val="black"/>
                </a:solidFill>
              </a:rPr>
              <a:t>ESA:</a:t>
            </a:r>
            <a:endParaRPr lang="en-US" sz="1600" dirty="0">
              <a:solidFill>
                <a:prstClr val="black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548710" y="1206426"/>
            <a:ext cx="53335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solidFill>
                  <a:prstClr val="black"/>
                </a:solidFill>
              </a:rPr>
              <a:t>3-month IV iron dose (expressed as average mg/month):</a:t>
            </a: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2204421"/>
              </p:ext>
            </p:extLst>
          </p:nvPr>
        </p:nvGraphicFramePr>
        <p:xfrm>
          <a:off x="812796" y="5480920"/>
          <a:ext cx="11226806" cy="55829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88122">
                  <a:extLst>
                    <a:ext uri="{9D8B030D-6E8A-4147-A177-3AD203B41FA5}">
                      <a16:colId xmlns:a16="http://schemas.microsoft.com/office/drawing/2014/main" val="785890902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1064767771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3776311127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759848724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708823409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1284219581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961101809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3636549305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4245422561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8090980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384643006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122611736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1773399857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3518146086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179783484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745610054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909242814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673975041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4212647392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073909380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2014788450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418903324"/>
                    </a:ext>
                  </a:extLst>
                </a:gridCol>
                <a:gridCol w="488122">
                  <a:extLst>
                    <a:ext uri="{9D8B030D-6E8A-4147-A177-3AD203B41FA5}">
                      <a16:colId xmlns:a16="http://schemas.microsoft.com/office/drawing/2014/main" val="1804682833"/>
                    </a:ext>
                  </a:extLst>
                </a:gridCol>
              </a:tblGrid>
              <a:tr h="2791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&lt;2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0-2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5-29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30-34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+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&lt;2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0-2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5-29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0-3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+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&lt;2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0-2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5-29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0-3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+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&lt;20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0-2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25-29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0-34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35+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2457471"/>
                  </a:ext>
                </a:extLst>
              </a:tr>
              <a:tr h="279146"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effectLst/>
                          <a:latin typeface="+mn-lt"/>
                        </a:rPr>
                        <a:t>0 (units/week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effectLst/>
                          <a:latin typeface="+mn-lt"/>
                        </a:rPr>
                        <a:t>&lt;5,0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effectLst/>
                          <a:latin typeface="+mn-lt"/>
                        </a:rPr>
                        <a:t>5,000-20,0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 smtClean="0">
                          <a:effectLst/>
                          <a:latin typeface="+mn-lt"/>
                        </a:rPr>
                        <a:t>&gt;20,00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219" marR="7219" marT="7219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827888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19008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DOPPS_Grayscale">
  <a:themeElements>
    <a:clrScheme name="DOPPS_Grayscale">
      <a:dk1>
        <a:sysClr val="windowText" lastClr="000000"/>
      </a:dk1>
      <a:lt1>
        <a:sysClr val="window" lastClr="FFFFFF"/>
      </a:lt1>
      <a:dk2>
        <a:srgbClr val="000000"/>
      </a:dk2>
      <a:lt2>
        <a:srgbClr val="F8F8F8"/>
      </a:lt2>
      <a:accent1>
        <a:srgbClr val="3C3C3C"/>
      </a:accent1>
      <a:accent2>
        <a:srgbClr val="646464"/>
      </a:accent2>
      <a:accent3>
        <a:srgbClr val="969696"/>
      </a:accent3>
      <a:accent4>
        <a:srgbClr val="B2B2B2"/>
      </a:accent4>
      <a:accent5>
        <a:srgbClr val="DDDDDD"/>
      </a:accent5>
      <a:accent6>
        <a:srgbClr val="000000"/>
      </a:accent6>
      <a:hlink>
        <a:srgbClr val="5F5F5F"/>
      </a:hlink>
      <a:folHlink>
        <a:srgbClr val="919191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3</TotalTime>
  <Words>81</Words>
  <Application>Microsoft Office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DOPPS_Grayscale</vt:lpstr>
      <vt:lpstr>PowerPoint Presentation</vt:lpstr>
    </vt:vector>
  </TitlesOfParts>
  <Company>Arbor Research Collaborative for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justed* Association of IV Iron dose with change in hemoglobin</dc:title>
  <dc:creator>Maria Larkina</dc:creator>
  <cp:lastModifiedBy>J McCready-Maynes</cp:lastModifiedBy>
  <cp:revision>31</cp:revision>
  <dcterms:created xsi:type="dcterms:W3CDTF">2017-04-28T20:43:38Z</dcterms:created>
  <dcterms:modified xsi:type="dcterms:W3CDTF">2017-05-08T14:52:01Z</dcterms:modified>
</cp:coreProperties>
</file>